
<file path=[Content_Types].xml><?xml version="1.0" encoding="utf-8"?>
<Types xmlns="http://schemas.openxmlformats.org/package/2006/content-types"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6" autoAdjust="0"/>
    <p:restoredTop sz="94660"/>
  </p:normalViewPr>
  <p:slideViewPr>
    <p:cSldViewPr snapToGrid="0">
      <p:cViewPr varScale="1">
        <p:scale>
          <a:sx n="162" d="100"/>
          <a:sy n="162" d="100"/>
        </p:scale>
        <p:origin x="184" y="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A0B696-7859-4EC1-A519-80632506984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F52E3E1-97EB-4C2A-AD15-5624711904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92935FC-A24C-4EDD-AB4A-F9AF88ABEB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BCD66BE-3937-46FF-89AA-7CE372AB74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6180D28-8969-488C-972D-C31850C62A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3814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E3E8A8-60E5-44C9-BE36-A03C43C4BA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F5D55B1-B8A2-4CC9-944E-CFF13B8735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3DB70E0-6466-4A55-8711-E10356B345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8CB71BD-D02B-45A5-A35A-C3E50E7A14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340AF46-F040-48C6-8EDB-C005E798EE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00682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31B11E7-4DA6-4627-8A81-E0BC4BF1555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5A09EBD-5BF1-4D0E-BE48-010CB04E6A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D630981-EB96-45A6-AB5B-66EBBF13A3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39B487E-FBCC-4CDE-BDAC-E817B5EC1B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F845273-99D5-4B5A-8B87-3D19D27EC4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7897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1453144-1E3B-43B1-A37A-BE41415A8C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429DCF-5CE9-4A07-A435-8D2DDC0655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EE3CC04-FDE2-4840-BA96-35045539EF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787D178-ED18-45F2-BE82-EBC945CCE9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9E5349C-BC34-4E19-A1D4-A72AB19F15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20252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7F5498F-B100-44DE-94C3-1F64A18B05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7B9A6B2-3D0B-4B4B-889F-3849967B84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6F4A69A-77E3-4E37-9125-E16B15D8CD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0659D7C-974D-4057-97CF-B803B3EBED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4E76DC1-2147-41EC-BB0B-9D30A013DD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59746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CC28B14-682B-4BD8-A235-9A4DB67F28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B59AC6A-C340-4607-888E-A1ED2EB0E5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3C803A5-C34C-4AD9-8494-B63AD20C43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267D9E2-5F58-48CB-BE61-3AEFFDE958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48B9864-D007-4DDC-84B3-1875E90521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6C4A79E-15FD-43F4-BCCD-46E1BCD7C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0862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0F9388-F099-451C-BBD2-A17756D1E9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3F91D23-32DB-4959-9756-91F4D21DF9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0BFE4EA-D3DB-4320-8EE6-650E72614B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87400F7-7CD3-4ECA-B93F-FD867F76EC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E976320-F088-42ED-8159-5BC6963A58E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3043590-C847-49F1-86C3-29FFE38835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623F5C9-C065-4283-9E8E-F73398B6E9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5EED3C7-7671-4E43-89D3-45B3937A01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1203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8C43AAE-567F-4ACF-9836-B6D6077483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75D5A4D-6BC6-4B8B-AB63-6F6DE361C5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CAE1715-99E4-4653-8F9D-67665CAAE6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7AE3871-0FBF-4FE2-B627-5A7F84996F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8303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62B5A12-7338-4A00-9B4F-F2283270DE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DFBD5BF-0FB6-4866-AEAB-FC059824FC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4333DCE-C377-4C2E-98E9-771D25BAFA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3234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B0A97CA-0D84-43B7-AC06-D9FE880ABA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33B87E9-35AE-4C5C-B0AA-879F7E402DF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BB6C410-21CC-4129-BD99-A8037E99BE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6FA486B-7489-44D1-8B0F-6328042A5F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05C0A17-7FF2-491F-B909-1000988647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79EA884-031C-456F-9935-318BC7571B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23267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9565CC-A06C-40C7-8CD8-A4D02BFD42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CAAB81F-B69F-4FD0-A02A-57A2DE6A0A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0228B3E-3447-4B4C-8517-C5B1BDEE40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6548515-C854-4101-A9B1-884524F148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99602FD-FD49-41CE-9471-DDBC6A1D20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65CFE28-B0BE-4734-9C4E-9B85846C5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4104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B4C9201-D464-4D46-A7E4-860791FFDE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4704A8F-1525-4765-80FF-A1C4DB1F11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E735455-BBF2-47D4-A8EE-1C50C0D578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CB6E9E-9E5D-4FEE-9FFA-E239C726439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6727499-805B-49B1-B15A-1961605618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672361D-412E-4B48-A7DC-47AE318FD4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158B95-3398-4AAB-9088-D5716D54D3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3343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gif"/><Relationship Id="rId4" Type="http://schemas.openxmlformats.org/officeDocument/2006/relationships/image" Target="../media/image3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48C7E1FA-780A-45F7-B26D-8A5D5EE2BC6E}"/>
              </a:ext>
            </a:extLst>
          </p:cNvPr>
          <p:cNvGrpSpPr/>
          <p:nvPr/>
        </p:nvGrpSpPr>
        <p:grpSpPr>
          <a:xfrm>
            <a:off x="72869" y="547597"/>
            <a:ext cx="11979551" cy="4684543"/>
            <a:chOff x="72869" y="1327244"/>
            <a:chExt cx="11979551" cy="4684543"/>
          </a:xfrm>
        </p:grpSpPr>
        <p:pic>
          <p:nvPicPr>
            <p:cNvPr id="19" name="図 18">
              <a:extLst>
                <a:ext uri="{FF2B5EF4-FFF2-40B4-BE49-F238E27FC236}">
                  <a16:creationId xmlns:a16="http://schemas.microsoft.com/office/drawing/2014/main" id="{3991E668-C0A2-4D68-9FF6-8AB7D1D947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819" t="28173" r="26864" b="29228"/>
            <a:stretch/>
          </p:blipFill>
          <p:spPr>
            <a:xfrm>
              <a:off x="72869" y="1667436"/>
              <a:ext cx="2784938" cy="4317928"/>
            </a:xfrm>
            <a:prstGeom prst="rect">
              <a:avLst/>
            </a:prstGeom>
          </p:spPr>
        </p:pic>
        <p:pic>
          <p:nvPicPr>
            <p:cNvPr id="20" name="図 19">
              <a:extLst>
                <a:ext uri="{FF2B5EF4-FFF2-40B4-BE49-F238E27FC236}">
                  <a16:creationId xmlns:a16="http://schemas.microsoft.com/office/drawing/2014/main" id="{BE2537AF-036B-4D0F-A425-2F16099B624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30493" y="1667436"/>
              <a:ext cx="2784936" cy="4317928"/>
            </a:xfrm>
            <a:prstGeom prst="rect">
              <a:avLst/>
            </a:prstGeom>
          </p:spPr>
        </p:pic>
        <p:pic>
          <p:nvPicPr>
            <p:cNvPr id="21" name="図 20">
              <a:extLst>
                <a:ext uri="{FF2B5EF4-FFF2-40B4-BE49-F238E27FC236}">
                  <a16:creationId xmlns:a16="http://schemas.microsoft.com/office/drawing/2014/main" id="{71FBAA68-B4C9-4355-B805-7DEAB3978B7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01561" y="1667436"/>
              <a:ext cx="2784936" cy="4317928"/>
            </a:xfrm>
            <a:prstGeom prst="rect">
              <a:avLst/>
            </a:prstGeom>
          </p:spPr>
        </p:pic>
        <p:pic>
          <p:nvPicPr>
            <p:cNvPr id="22" name="図 21">
              <a:extLst>
                <a:ext uri="{FF2B5EF4-FFF2-40B4-BE49-F238E27FC236}">
                  <a16:creationId xmlns:a16="http://schemas.microsoft.com/office/drawing/2014/main" id="{0651D73E-B46C-4BA5-A319-68F19F6A8C2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72630" y="1667436"/>
              <a:ext cx="2784936" cy="4317928"/>
            </a:xfrm>
            <a:prstGeom prst="rect">
              <a:avLst/>
            </a:prstGeom>
          </p:spPr>
        </p:pic>
        <p:pic>
          <p:nvPicPr>
            <p:cNvPr id="23" name="図 22">
              <a:extLst>
                <a:ext uri="{FF2B5EF4-FFF2-40B4-BE49-F238E27FC236}">
                  <a16:creationId xmlns:a16="http://schemas.microsoft.com/office/drawing/2014/main" id="{FDADD72A-6649-4319-84CB-8122DF38E012}"/>
                </a:ext>
              </a:extLst>
            </p:cNvPr>
            <p:cNvPicPr>
              <a:picLocks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472774" y="1673787"/>
              <a:ext cx="72000" cy="4338000"/>
            </a:xfrm>
            <a:prstGeom prst="rect">
              <a:avLst/>
            </a:prstGeom>
          </p:spPr>
        </p:pic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D191EA26-5854-4D52-A0C6-3D9183C2183D}"/>
                </a:ext>
              </a:extLst>
            </p:cNvPr>
            <p:cNvSpPr txBox="1"/>
            <p:nvPr/>
          </p:nvSpPr>
          <p:spPr>
            <a:xfrm rot="16200000">
              <a:off x="10941026" y="3672511"/>
              <a:ext cx="13712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 radioactivity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8CE5D7DF-0B1F-463B-B8F3-E7895D8EEABA}"/>
                </a:ext>
              </a:extLst>
            </p:cNvPr>
            <p:cNvSpPr txBox="1"/>
            <p:nvPr/>
          </p:nvSpPr>
          <p:spPr>
            <a:xfrm>
              <a:off x="11508681" y="1589710"/>
              <a:ext cx="54373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gh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B17D2716-9195-4CA3-A974-DD3CBED987A8}"/>
                </a:ext>
              </a:extLst>
            </p:cNvPr>
            <p:cNvSpPr txBox="1"/>
            <p:nvPr/>
          </p:nvSpPr>
          <p:spPr>
            <a:xfrm>
              <a:off x="11526728" y="5704010"/>
              <a:ext cx="5132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w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9D677A67-95D4-4A1B-92FE-B385DC8000A1}"/>
                </a:ext>
              </a:extLst>
            </p:cNvPr>
            <p:cNvSpPr txBox="1"/>
            <p:nvPr/>
          </p:nvSpPr>
          <p:spPr>
            <a:xfrm>
              <a:off x="3749727" y="1327244"/>
              <a:ext cx="11464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 h lighting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A1662BC1-6A64-40C1-BAA8-24CC0FD67AF2}"/>
                </a:ext>
              </a:extLst>
            </p:cNvPr>
            <p:cNvSpPr txBox="1"/>
            <p:nvPr/>
          </p:nvSpPr>
          <p:spPr>
            <a:xfrm>
              <a:off x="6620795" y="1327244"/>
              <a:ext cx="11464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5 h lighting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C27E3FB7-3171-466B-9FDA-0E1E4AECDFE7}"/>
                </a:ext>
              </a:extLst>
            </p:cNvPr>
            <p:cNvSpPr txBox="1"/>
            <p:nvPr/>
          </p:nvSpPr>
          <p:spPr>
            <a:xfrm>
              <a:off x="9559190" y="1327244"/>
              <a:ext cx="101181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 h lighting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28A34135-DAA5-48BB-973D-DE2B0BFB8019}"/>
                </a:ext>
              </a:extLst>
            </p:cNvPr>
            <p:cNvSpPr txBox="1"/>
            <p:nvPr/>
          </p:nvSpPr>
          <p:spPr>
            <a:xfrm>
              <a:off x="404791" y="1327244"/>
              <a:ext cx="212109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eld of view of the PETIS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54BAEB7-FB37-47C5-A71C-3AFC0D8F1AAC}"/>
              </a:ext>
            </a:extLst>
          </p:cNvPr>
          <p:cNvSpPr txBox="1"/>
          <p:nvPr/>
        </p:nvSpPr>
        <p:spPr>
          <a:xfrm>
            <a:off x="0" y="5770103"/>
            <a:ext cx="1219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</a:t>
            </a:r>
            <a:r>
              <a: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: Animation of </a:t>
            </a:r>
            <a:r>
              <a:rPr kumimoji="1"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-photoynshtae translocation to strawberry fruits of Plant A in 0.5 h, 4.5 h and 9 h lighting treatments.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18698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45</Words>
  <Application>Microsoft Office PowerPoint</Application>
  <PresentationFormat>ワイド画面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悠 悠</dc:creator>
  <cp:lastModifiedBy>Yuta Miyoshi</cp:lastModifiedBy>
  <cp:revision>11</cp:revision>
  <dcterms:created xsi:type="dcterms:W3CDTF">2021-03-28T23:34:59Z</dcterms:created>
  <dcterms:modified xsi:type="dcterms:W3CDTF">2021-03-31T10:12:03Z</dcterms:modified>
</cp:coreProperties>
</file>